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72" r:id="rId1"/>
  </p:sldMasterIdLst>
  <p:sldIdLst>
    <p:sldId id="261" r:id="rId2"/>
  </p:sldIdLst>
  <p:sldSz cx="10080625" cy="8640763"/>
  <p:notesSz cx="6858000" cy="9144000"/>
  <p:defaultTextStyle>
    <a:defPPr>
      <a:defRPr lang="en-US"/>
    </a:defPPr>
    <a:lvl1pPr marL="0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1pPr>
    <a:lvl2pPr marL="420686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2pPr>
    <a:lvl3pPr marL="841371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3pPr>
    <a:lvl4pPr marL="1262059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4pPr>
    <a:lvl5pPr marL="1682744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5pPr>
    <a:lvl6pPr marL="2103430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6pPr>
    <a:lvl7pPr marL="2524116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7pPr>
    <a:lvl8pPr marL="2944802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8pPr>
    <a:lvl9pPr marL="3365489" algn="l" defTabSz="841371" rtl="0" eaLnBrk="1" latinLnBrk="0" hangingPunct="1">
      <a:defRPr sz="16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50" autoAdjust="0"/>
    <p:restoredTop sz="94660"/>
  </p:normalViewPr>
  <p:slideViewPr>
    <p:cSldViewPr snapToGrid="0">
      <p:cViewPr varScale="1">
        <p:scale>
          <a:sx n="52" d="100"/>
          <a:sy n="52" d="100"/>
        </p:scale>
        <p:origin x="1155" y="29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414125"/>
            <a:ext cx="8568531" cy="3008266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4538401"/>
            <a:ext cx="7560469" cy="2086184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07783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61902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460041"/>
            <a:ext cx="2173635" cy="73226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460041"/>
            <a:ext cx="6394896" cy="732264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80437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50038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2154193"/>
            <a:ext cx="8694539" cy="3594317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5782513"/>
            <a:ext cx="8694539" cy="1890166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70737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2300203"/>
            <a:ext cx="4284266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2300203"/>
            <a:ext cx="4284266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6558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60043"/>
            <a:ext cx="8694539" cy="167014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2118188"/>
            <a:ext cx="4264576" cy="103809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3156278"/>
            <a:ext cx="4264576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2118188"/>
            <a:ext cx="4285579" cy="103809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3156278"/>
            <a:ext cx="4285579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298016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469525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7344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76051"/>
            <a:ext cx="3251264" cy="2016178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244112"/>
            <a:ext cx="5103316" cy="6140542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592229"/>
            <a:ext cx="3251264" cy="4802425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99478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76051"/>
            <a:ext cx="3251264" cy="2016178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244112"/>
            <a:ext cx="5103316" cy="6140542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592229"/>
            <a:ext cx="3251264" cy="4802425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46806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460043"/>
            <a:ext cx="8694539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2300203"/>
            <a:ext cx="8694539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8008709"/>
            <a:ext cx="226814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DF12E-CE2F-41C3-99F9-A26E0F6A6A0D}" type="datetimeFigureOut">
              <a:rPr lang="en-SG" smtClean="0"/>
              <a:t>22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8008709"/>
            <a:ext cx="340221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8008709"/>
            <a:ext cx="226814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1DA8-B003-46D4-98A4-5B45E5F86D6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42883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73" r:id="rId1"/>
    <p:sldLayoutId id="2147483974" r:id="rId2"/>
    <p:sldLayoutId id="2147483975" r:id="rId3"/>
    <p:sldLayoutId id="2147483976" r:id="rId4"/>
    <p:sldLayoutId id="2147483977" r:id="rId5"/>
    <p:sldLayoutId id="2147483978" r:id="rId6"/>
    <p:sldLayoutId id="2147483979" r:id="rId7"/>
    <p:sldLayoutId id="2147483980" r:id="rId8"/>
    <p:sldLayoutId id="2147483981" r:id="rId9"/>
    <p:sldLayoutId id="2147483982" r:id="rId10"/>
    <p:sldLayoutId id="2147483983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4" name="Rectangle 673"/>
          <p:cNvSpPr/>
          <p:nvPr/>
        </p:nvSpPr>
        <p:spPr>
          <a:xfrm>
            <a:off x="332318" y="7149845"/>
            <a:ext cx="9464475" cy="12448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SG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SG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curacy distribution of 100 models learned independently from (A) two-class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three-class datasets using PART (PT) and random forest (RF). The datasets contain the concatenated alignments of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AV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s. Wilcoxon signed-rank sum test is used to test the null hypothesis that the median of the accuracy of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 model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 greater than that of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F models.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ed dashed line indicates the accuracy of zero rule learner,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ile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lue horizontal lines indicate significant difference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SG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nferroni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justed p-value &lt; 0.05) between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 and RF models 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rated from the same protein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ignment.</a:t>
            </a:r>
            <a:endParaRPr lang="en-SG" sz="1400" b="1" dirty="0" smtClean="0">
              <a:solidFill>
                <a:srgbClr val="FF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75" name="Picture 67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1945" y="4037511"/>
            <a:ext cx="5943600" cy="2705100"/>
          </a:xfrm>
          <a:prstGeom prst="rect">
            <a:avLst/>
          </a:prstGeom>
        </p:spPr>
      </p:pic>
      <p:cxnSp>
        <p:nvCxnSpPr>
          <p:cNvPr id="676" name="Straight Connector 675"/>
          <p:cNvCxnSpPr/>
          <p:nvPr/>
        </p:nvCxnSpPr>
        <p:spPr>
          <a:xfrm flipV="1">
            <a:off x="2489016" y="6709140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7" name="Straight Connector 676"/>
          <p:cNvCxnSpPr/>
          <p:nvPr/>
        </p:nvCxnSpPr>
        <p:spPr>
          <a:xfrm flipV="1">
            <a:off x="3250390" y="6707326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8" name="Straight Connector 677"/>
          <p:cNvCxnSpPr/>
          <p:nvPr/>
        </p:nvCxnSpPr>
        <p:spPr>
          <a:xfrm flipV="1">
            <a:off x="3995845" y="6707326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9" name="Straight Connector 678"/>
          <p:cNvCxnSpPr/>
          <p:nvPr/>
        </p:nvCxnSpPr>
        <p:spPr>
          <a:xfrm flipV="1">
            <a:off x="4745627" y="6705512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0" name="Straight Connector 679"/>
          <p:cNvCxnSpPr/>
          <p:nvPr/>
        </p:nvCxnSpPr>
        <p:spPr>
          <a:xfrm flipV="1">
            <a:off x="5503804" y="6703698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1" name="Straight Connector 680"/>
          <p:cNvCxnSpPr/>
          <p:nvPr/>
        </p:nvCxnSpPr>
        <p:spPr>
          <a:xfrm flipV="1">
            <a:off x="6248142" y="6701884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2" name="Straight Connector 681"/>
          <p:cNvCxnSpPr/>
          <p:nvPr/>
        </p:nvCxnSpPr>
        <p:spPr>
          <a:xfrm flipV="1">
            <a:off x="7009516" y="6700070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3" name="TextBox 682"/>
          <p:cNvSpPr txBox="1"/>
          <p:nvPr/>
        </p:nvSpPr>
        <p:spPr>
          <a:xfrm>
            <a:off x="2483391" y="6715873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V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4" name="TextBox 683"/>
          <p:cNvSpPr txBox="1"/>
          <p:nvPr/>
        </p:nvSpPr>
        <p:spPr>
          <a:xfrm>
            <a:off x="3199758" y="6712768"/>
            <a:ext cx="69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ALB/C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5" name="TextBox 684"/>
          <p:cNvSpPr txBox="1"/>
          <p:nvPr/>
        </p:nvSpPr>
        <p:spPr>
          <a:xfrm>
            <a:off x="3933550" y="6713207"/>
            <a:ext cx="722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6" name="TextBox 685"/>
          <p:cNvSpPr txBox="1"/>
          <p:nvPr/>
        </p:nvSpPr>
        <p:spPr>
          <a:xfrm>
            <a:off x="4750949" y="6718590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7" name="TextBox 686"/>
          <p:cNvSpPr txBox="1"/>
          <p:nvPr/>
        </p:nvSpPr>
        <p:spPr>
          <a:xfrm>
            <a:off x="5501600" y="6707706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1N1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8" name="TextBox 687"/>
          <p:cNvSpPr txBox="1"/>
          <p:nvPr/>
        </p:nvSpPr>
        <p:spPr>
          <a:xfrm>
            <a:off x="6231887" y="6705512"/>
            <a:ext cx="6277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3N2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9" name="TextBox 688"/>
          <p:cNvSpPr txBox="1"/>
          <p:nvPr/>
        </p:nvSpPr>
        <p:spPr>
          <a:xfrm>
            <a:off x="7012759" y="6713207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5N1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0" name="Straight Connector 689"/>
          <p:cNvCxnSpPr/>
          <p:nvPr/>
        </p:nvCxnSpPr>
        <p:spPr>
          <a:xfrm>
            <a:off x="2455217" y="4158479"/>
            <a:ext cx="663623" cy="556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1" name="Straight Connector 690"/>
          <p:cNvCxnSpPr/>
          <p:nvPr/>
        </p:nvCxnSpPr>
        <p:spPr>
          <a:xfrm>
            <a:off x="3202479" y="4161201"/>
            <a:ext cx="663623" cy="556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2" name="Straight Connector 691"/>
          <p:cNvCxnSpPr/>
          <p:nvPr/>
        </p:nvCxnSpPr>
        <p:spPr>
          <a:xfrm>
            <a:off x="6970711" y="4164435"/>
            <a:ext cx="663623" cy="556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3" name="Picture 69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5265" y="555518"/>
            <a:ext cx="5943600" cy="2705100"/>
          </a:xfrm>
          <a:prstGeom prst="rect">
            <a:avLst/>
          </a:prstGeom>
        </p:spPr>
      </p:pic>
      <p:cxnSp>
        <p:nvCxnSpPr>
          <p:cNvPr id="694" name="Straight Connector 693"/>
          <p:cNvCxnSpPr/>
          <p:nvPr/>
        </p:nvCxnSpPr>
        <p:spPr>
          <a:xfrm flipV="1">
            <a:off x="2498254" y="3252824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5" name="Straight Connector 694"/>
          <p:cNvCxnSpPr/>
          <p:nvPr/>
        </p:nvCxnSpPr>
        <p:spPr>
          <a:xfrm flipV="1">
            <a:off x="3259628" y="3251010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6" name="Straight Connector 695"/>
          <p:cNvCxnSpPr/>
          <p:nvPr/>
        </p:nvCxnSpPr>
        <p:spPr>
          <a:xfrm flipV="1">
            <a:off x="4005083" y="3251010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7" name="Straight Connector 696"/>
          <p:cNvCxnSpPr/>
          <p:nvPr/>
        </p:nvCxnSpPr>
        <p:spPr>
          <a:xfrm flipV="1">
            <a:off x="4754865" y="3249196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8" name="Straight Connector 697"/>
          <p:cNvCxnSpPr/>
          <p:nvPr/>
        </p:nvCxnSpPr>
        <p:spPr>
          <a:xfrm flipV="1">
            <a:off x="5513042" y="3247382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9" name="Straight Connector 698"/>
          <p:cNvCxnSpPr/>
          <p:nvPr/>
        </p:nvCxnSpPr>
        <p:spPr>
          <a:xfrm flipV="1">
            <a:off x="6257380" y="3245568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0" name="Straight Connector 699"/>
          <p:cNvCxnSpPr/>
          <p:nvPr/>
        </p:nvCxnSpPr>
        <p:spPr>
          <a:xfrm flipV="1">
            <a:off x="7018754" y="3243754"/>
            <a:ext cx="586014" cy="1814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1" name="TextBox 700"/>
          <p:cNvSpPr txBox="1"/>
          <p:nvPr/>
        </p:nvSpPr>
        <p:spPr>
          <a:xfrm>
            <a:off x="2492629" y="3259557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V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2" name="TextBox 701"/>
          <p:cNvSpPr txBox="1"/>
          <p:nvPr/>
        </p:nvSpPr>
        <p:spPr>
          <a:xfrm>
            <a:off x="3208996" y="3256452"/>
            <a:ext cx="69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ALB/C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3" name="TextBox 702"/>
          <p:cNvSpPr txBox="1"/>
          <p:nvPr/>
        </p:nvSpPr>
        <p:spPr>
          <a:xfrm>
            <a:off x="3942788" y="3256891"/>
            <a:ext cx="722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4" name="TextBox 703"/>
          <p:cNvSpPr txBox="1"/>
          <p:nvPr/>
        </p:nvSpPr>
        <p:spPr>
          <a:xfrm>
            <a:off x="4760187" y="3262274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5" name="TextBox 704"/>
          <p:cNvSpPr txBox="1"/>
          <p:nvPr/>
        </p:nvSpPr>
        <p:spPr>
          <a:xfrm>
            <a:off x="5510838" y="3251390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1N1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6" name="TextBox 705"/>
          <p:cNvSpPr txBox="1"/>
          <p:nvPr/>
        </p:nvSpPr>
        <p:spPr>
          <a:xfrm>
            <a:off x="6241125" y="3249196"/>
            <a:ext cx="6277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3N2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7" name="TextBox 706"/>
          <p:cNvSpPr txBox="1"/>
          <p:nvPr/>
        </p:nvSpPr>
        <p:spPr>
          <a:xfrm>
            <a:off x="7021997" y="3256891"/>
            <a:ext cx="586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5N1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8" name="Rectangle 707"/>
          <p:cNvSpPr/>
          <p:nvPr/>
        </p:nvSpPr>
        <p:spPr>
          <a:xfrm>
            <a:off x="276920" y="3761961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Three</a:t>
            </a:r>
            <a:r>
              <a:rPr lang="en-SG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lass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09" name="Rectangle 708"/>
          <p:cNvSpPr/>
          <p:nvPr/>
        </p:nvSpPr>
        <p:spPr>
          <a:xfrm>
            <a:off x="276920" y="282649"/>
            <a:ext cx="9468154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Two-class </a:t>
            </a:r>
            <a:r>
              <a:rPr lang="en-SG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sets</a:t>
            </a:r>
            <a:endParaRPr lang="en-SG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313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2</TotalTime>
  <Words>134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van</dc:creator>
  <cp:lastModifiedBy>fivan</cp:lastModifiedBy>
  <cp:revision>227</cp:revision>
  <dcterms:created xsi:type="dcterms:W3CDTF">2019-01-11T06:23:12Z</dcterms:created>
  <dcterms:modified xsi:type="dcterms:W3CDTF">2019-07-22T09:17:22Z</dcterms:modified>
</cp:coreProperties>
</file>